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60" d="100"/>
          <a:sy n="160" d="100"/>
        </p:scale>
        <p:origin x="-72" y="50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9E39F929-A948-46A3-B0D5-760C3B69E1EB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44C8964-3C85-43FA-BB6D-4E9232BE3B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994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2F914DE-26FE-4DA2-A022-10A2966BA1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9847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41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140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84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844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267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745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466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134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794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914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141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F2A89B-AA2B-49AF-A6AE-002BA9BA24B3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E526D-04E7-4010-A156-BC21B613F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503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wmf"/><Relationship Id="rId3" Type="http://schemas.openxmlformats.org/officeDocument/2006/relationships/image" Target="../media/image1.wmf"/><Relationship Id="rId7" Type="http://schemas.openxmlformats.org/officeDocument/2006/relationships/image" Target="../media/image5.w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wmf"/><Relationship Id="rId5" Type="http://schemas.openxmlformats.org/officeDocument/2006/relationships/image" Target="../media/image3.wmf"/><Relationship Id="rId4" Type="http://schemas.openxmlformats.org/officeDocument/2006/relationships/image" Target="../media/image2.wmf"/><Relationship Id="rId9" Type="http://schemas.openxmlformats.org/officeDocument/2006/relationships/image" Target="../media/image7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2" descr="C:\Users\E0195460\AppData\Local\Temp\TempGLFile556927908023896433.eps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090" y="2208747"/>
            <a:ext cx="1279959" cy="12853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E0195460\AppData\Local\Temp\TempGLFile8870377821500993607.eps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1245" y="685800"/>
            <a:ext cx="1279959" cy="12853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E0195460\AppData\Local\Temp\TempGLFile5729317833604930314.eps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5990" y="685800"/>
            <a:ext cx="1279959" cy="12853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C:\Users\E0195460\AppData\Local\Temp\TempGLFile2740970152078894789.eps"/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258" y="685800"/>
            <a:ext cx="1279959" cy="12853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E0195460\AppData\Local\Temp\TempGLFile2734799720212178832.eps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63582" y="685800"/>
            <a:ext cx="1279959" cy="12853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4" descr="C:\Users\E0195460\AppData\Local\Temp\TempGLFile2917890870336556489.eps"/>
          <p:cNvPicPr preferRelativeResize="0"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4458" y="2208747"/>
            <a:ext cx="1279959" cy="12853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3" descr="C:\Users\E0195460\AppData\Local\Temp\TempGLFile1543425941176034067.eps"/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636" y="2208747"/>
            <a:ext cx="1279959" cy="12853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/>
          <p:cNvSpPr/>
          <p:nvPr/>
        </p:nvSpPr>
        <p:spPr>
          <a:xfrm>
            <a:off x="3564118" y="2791109"/>
            <a:ext cx="1091872" cy="191068"/>
          </a:xfrm>
          <a:prstGeom prst="rect">
            <a:avLst/>
          </a:prstGeom>
        </p:spPr>
        <p:txBody>
          <a:bodyPr wrap="square" lIns="67300" tIns="33650" rIns="67300" bIns="33650">
            <a:spAutoFit/>
          </a:bodyPr>
          <a:lstStyle/>
          <a:p>
            <a:pPr defTabSz="672809" fontAlgn="auto">
              <a:spcBef>
                <a:spcPts val="0"/>
              </a:spcBef>
              <a:spcAft>
                <a:spcPts val="0"/>
              </a:spcAft>
            </a:pPr>
            <a:r>
              <a:rPr lang="en-US" sz="800" b="1" dirty="0" smtClean="0">
                <a:solidFill>
                  <a:srgbClr val="000000"/>
                </a:solidFill>
                <a:latin typeface="Arial"/>
                <a:cs typeface="Arial"/>
              </a:rPr>
              <a:t>Satellite Cells</a:t>
            </a:r>
            <a:endParaRPr lang="en-US" sz="1100" dirty="0">
              <a:solidFill>
                <a:srgbClr val="444492"/>
              </a:solidFill>
              <a:latin typeface="Arial"/>
              <a:cs typeface="Arial"/>
            </a:endParaRPr>
          </a:p>
        </p:txBody>
      </p:sp>
      <p:sp>
        <p:nvSpPr>
          <p:cNvPr id="2" name="TextBox 1"/>
          <p:cNvSpPr txBox="1"/>
          <p:nvPr/>
        </p:nvSpPr>
        <p:spPr>
          <a:xfrm rot="16200000">
            <a:off x="-129257" y="1222069"/>
            <a:ext cx="457200" cy="1551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smtClean="0"/>
              <a:t>SSC-A</a:t>
            </a:r>
            <a:endParaRPr lang="en-US" sz="8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4417310" y="1187814"/>
            <a:ext cx="457200" cy="1551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smtClean="0"/>
              <a:t>SSC-A</a:t>
            </a:r>
            <a:endParaRPr lang="en-US" sz="8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-150687" y="2687036"/>
            <a:ext cx="457200" cy="1551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smtClean="0"/>
              <a:t>SSC-A</a:t>
            </a:r>
            <a:endParaRPr lang="en-US" sz="8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2896960" y="2718689"/>
            <a:ext cx="457200" cy="1551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smtClean="0"/>
              <a:t>SSC-A</a:t>
            </a:r>
            <a:endParaRPr lang="en-US" sz="8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1370626" y="1224402"/>
            <a:ext cx="457200" cy="1504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800" dirty="0" smtClean="0"/>
              <a:t>FSC-W</a:t>
            </a:r>
            <a:endParaRPr lang="en-US" sz="800" dirty="0"/>
          </a:p>
        </p:txBody>
      </p:sp>
      <p:sp>
        <p:nvSpPr>
          <p:cNvPr id="6" name="TextBox 5"/>
          <p:cNvSpPr txBox="1"/>
          <p:nvPr/>
        </p:nvSpPr>
        <p:spPr>
          <a:xfrm>
            <a:off x="2144216" y="1865376"/>
            <a:ext cx="877832" cy="926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800" dirty="0" smtClean="0"/>
              <a:t>FSC-H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613831" y="1865376"/>
            <a:ext cx="877832" cy="926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800" dirty="0" smtClean="0"/>
              <a:t>FSC-A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2917840" y="1167482"/>
            <a:ext cx="457200" cy="1518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800" dirty="0" smtClean="0"/>
              <a:t>SSC-W</a:t>
            </a:r>
            <a:endParaRPr lang="en-US" sz="800" dirty="0"/>
          </a:p>
        </p:txBody>
      </p:sp>
      <p:sp>
        <p:nvSpPr>
          <p:cNvPr id="36" name="TextBox 35"/>
          <p:cNvSpPr txBox="1"/>
          <p:nvPr/>
        </p:nvSpPr>
        <p:spPr>
          <a:xfrm>
            <a:off x="3634120" y="1865376"/>
            <a:ext cx="877832" cy="926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800" dirty="0" smtClean="0"/>
              <a:t>SSC-H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4828790" y="1865376"/>
            <a:ext cx="1295400" cy="992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800" dirty="0" smtClean="0"/>
              <a:t>PI-A – </a:t>
            </a:r>
            <a:r>
              <a:rPr lang="en-US" sz="800" dirty="0" err="1" smtClean="0"/>
              <a:t>Propidium</a:t>
            </a:r>
            <a:r>
              <a:rPr lang="en-US" sz="800" dirty="0" smtClean="0"/>
              <a:t> Iodide</a:t>
            </a:r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180138" y="3391736"/>
            <a:ext cx="1419087" cy="1121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800" dirty="0" smtClean="0"/>
              <a:t>PerCP-Cy5.5-A – CD31/CD45</a:t>
            </a:r>
            <a:endParaRPr lang="en-US" dirty="0"/>
          </a:p>
        </p:txBody>
      </p:sp>
      <p:sp>
        <p:nvSpPr>
          <p:cNvPr id="40" name="TextBox 39"/>
          <p:cNvSpPr txBox="1"/>
          <p:nvPr/>
        </p:nvSpPr>
        <p:spPr>
          <a:xfrm>
            <a:off x="1890716" y="3401568"/>
            <a:ext cx="1295400" cy="10235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800" dirty="0" smtClean="0"/>
              <a:t>BV421-A - PDGFR</a:t>
            </a:r>
            <a:r>
              <a:rPr lang="el-GR" sz="800" dirty="0" smtClean="0"/>
              <a:t>α</a:t>
            </a:r>
            <a:endParaRPr lang="en-US" dirty="0"/>
          </a:p>
        </p:txBody>
      </p:sp>
      <p:sp>
        <p:nvSpPr>
          <p:cNvPr id="41" name="TextBox 40"/>
          <p:cNvSpPr txBox="1"/>
          <p:nvPr/>
        </p:nvSpPr>
        <p:spPr>
          <a:xfrm rot="16200000">
            <a:off x="1124810" y="2611977"/>
            <a:ext cx="958917" cy="1524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800" dirty="0" smtClean="0"/>
              <a:t>BV605  - A – SCA1</a:t>
            </a:r>
            <a:endParaRPr lang="en-US" dirty="0"/>
          </a:p>
        </p:txBody>
      </p:sp>
      <p:sp>
        <p:nvSpPr>
          <p:cNvPr id="42" name="TextBox 41"/>
          <p:cNvSpPr txBox="1"/>
          <p:nvPr/>
        </p:nvSpPr>
        <p:spPr>
          <a:xfrm>
            <a:off x="3388450" y="3391736"/>
            <a:ext cx="1295400" cy="10235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800" dirty="0" smtClean="0"/>
              <a:t>PE-A - Integrin </a:t>
            </a:r>
            <a:r>
              <a:rPr lang="el-GR" sz="800" dirty="0" smtClean="0"/>
              <a:t>α</a:t>
            </a:r>
            <a:r>
              <a:rPr lang="en-US" sz="800" dirty="0" smtClean="0"/>
              <a:t>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51195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33</Words>
  <Application>Microsoft Office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anofi-aventi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ton, Christopher R&amp;D/US/EXT</dc:creator>
  <cp:lastModifiedBy>Penton, Christopher R&amp;D/US/EXT</cp:lastModifiedBy>
  <cp:revision>12</cp:revision>
  <cp:lastPrinted>2016-10-31T22:45:26Z</cp:lastPrinted>
  <dcterms:created xsi:type="dcterms:W3CDTF">2015-11-11T16:57:38Z</dcterms:created>
  <dcterms:modified xsi:type="dcterms:W3CDTF">2016-11-22T19:20:06Z</dcterms:modified>
</cp:coreProperties>
</file>